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8" r:id="rId3"/>
    <p:sldId id="257" r:id="rId4"/>
    <p:sldId id="258" r:id="rId5"/>
    <p:sldId id="259" r:id="rId6"/>
    <p:sldId id="260" r:id="rId7"/>
    <p:sldId id="261" r:id="rId8"/>
    <p:sldId id="262" r:id="rId9"/>
    <p:sldId id="269" r:id="rId10"/>
    <p:sldId id="270" r:id="rId11"/>
    <p:sldId id="263" r:id="rId12"/>
    <p:sldId id="264" r:id="rId13"/>
    <p:sldId id="265" r:id="rId14"/>
    <p:sldId id="266" r:id="rId15"/>
    <p:sldId id="267" r:id="rId16"/>
    <p:sldId id="271" r:id="rId17"/>
    <p:sldId id="272" r:id="rId1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91" d="100"/>
          <a:sy n="91" d="100"/>
        </p:scale>
        <p:origin x="351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4/6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9153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4/6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17127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4/6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00984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4/6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6554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4/6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3869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4/6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0924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4/6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5527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4/6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81623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4/6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4636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4/6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0515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CAAC1-B734-4340-A86E-CA4E7CC5E203}" type="datetimeFigureOut">
              <a:rPr lang="zh-CN" altLang="en-US" smtClean="0"/>
              <a:t>2024/6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70760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CCAAC1-B734-4340-A86E-CA4E7CC5E203}" type="datetimeFigureOut">
              <a:rPr lang="zh-CN" altLang="en-US" smtClean="0"/>
              <a:t>2024/6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ECCED5-EB18-4736-BCAC-018BA65879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52155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jpeg"/><Relationship Id="rId2" Type="http://schemas.openxmlformats.org/officeDocument/2006/relationships/image" Target="../media/image40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3.jpeg"/><Relationship Id="rId4" Type="http://schemas.openxmlformats.org/officeDocument/2006/relationships/image" Target="../media/image42.jpe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tiff"/><Relationship Id="rId3" Type="http://schemas.openxmlformats.org/officeDocument/2006/relationships/image" Target="../media/image45.tiff"/><Relationship Id="rId7" Type="http://schemas.openxmlformats.org/officeDocument/2006/relationships/image" Target="../media/image49.tiff"/><Relationship Id="rId2" Type="http://schemas.openxmlformats.org/officeDocument/2006/relationships/image" Target="../media/image4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8.tiff"/><Relationship Id="rId11" Type="http://schemas.openxmlformats.org/officeDocument/2006/relationships/image" Target="../media/image53.tiff"/><Relationship Id="rId5" Type="http://schemas.openxmlformats.org/officeDocument/2006/relationships/image" Target="../media/image47.tiff"/><Relationship Id="rId10" Type="http://schemas.openxmlformats.org/officeDocument/2006/relationships/image" Target="../media/image52.tiff"/><Relationship Id="rId4" Type="http://schemas.openxmlformats.org/officeDocument/2006/relationships/image" Target="../media/image46.tiff"/><Relationship Id="rId9" Type="http://schemas.openxmlformats.org/officeDocument/2006/relationships/image" Target="../media/image51.tiff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0.tiff"/><Relationship Id="rId3" Type="http://schemas.openxmlformats.org/officeDocument/2006/relationships/image" Target="../media/image55.tiff"/><Relationship Id="rId7" Type="http://schemas.openxmlformats.org/officeDocument/2006/relationships/image" Target="../media/image59.tiff"/><Relationship Id="rId2" Type="http://schemas.openxmlformats.org/officeDocument/2006/relationships/image" Target="../media/image5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8.tiff"/><Relationship Id="rId5" Type="http://schemas.openxmlformats.org/officeDocument/2006/relationships/image" Target="../media/image57.tiff"/><Relationship Id="rId4" Type="http://schemas.openxmlformats.org/officeDocument/2006/relationships/image" Target="../media/image56.tiff"/><Relationship Id="rId9" Type="http://schemas.openxmlformats.org/officeDocument/2006/relationships/image" Target="../media/image61.tif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tiff"/><Relationship Id="rId2" Type="http://schemas.openxmlformats.org/officeDocument/2006/relationships/image" Target="../media/image62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5.tiff"/><Relationship Id="rId4" Type="http://schemas.openxmlformats.org/officeDocument/2006/relationships/image" Target="../media/image64.tif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tiff"/><Relationship Id="rId2" Type="http://schemas.openxmlformats.org/officeDocument/2006/relationships/image" Target="../media/image66.tif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9.tiff"/><Relationship Id="rId2" Type="http://schemas.openxmlformats.org/officeDocument/2006/relationships/image" Target="../media/image68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1.tiff"/><Relationship Id="rId4" Type="http://schemas.openxmlformats.org/officeDocument/2006/relationships/image" Target="../media/image70.tif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3.jpeg"/><Relationship Id="rId2" Type="http://schemas.openxmlformats.org/officeDocument/2006/relationships/image" Target="../media/image72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5.jpeg"/><Relationship Id="rId4" Type="http://schemas.openxmlformats.org/officeDocument/2006/relationships/image" Target="../media/image74.jpe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jpeg"/><Relationship Id="rId2" Type="http://schemas.openxmlformats.org/officeDocument/2006/relationships/image" Target="../media/image7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0.jpeg"/><Relationship Id="rId5" Type="http://schemas.openxmlformats.org/officeDocument/2006/relationships/image" Target="../media/image79.jpeg"/><Relationship Id="rId4" Type="http://schemas.openxmlformats.org/officeDocument/2006/relationships/image" Target="../media/image78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tiff"/><Relationship Id="rId4" Type="http://schemas.openxmlformats.org/officeDocument/2006/relationships/image" Target="../media/image11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tiff"/><Relationship Id="rId4" Type="http://schemas.openxmlformats.org/officeDocument/2006/relationships/image" Target="../media/image18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f"/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3.tiff"/><Relationship Id="rId4" Type="http://schemas.openxmlformats.org/officeDocument/2006/relationships/image" Target="../media/image22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tiff"/><Relationship Id="rId7" Type="http://schemas.openxmlformats.org/officeDocument/2006/relationships/image" Target="../media/image29.tiff"/><Relationship Id="rId2" Type="http://schemas.openxmlformats.org/officeDocument/2006/relationships/image" Target="../media/image2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tiff"/><Relationship Id="rId5" Type="http://schemas.openxmlformats.org/officeDocument/2006/relationships/image" Target="../media/image27.tiff"/><Relationship Id="rId4" Type="http://schemas.openxmlformats.org/officeDocument/2006/relationships/image" Target="../media/image26.tif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tiff"/><Relationship Id="rId3" Type="http://schemas.openxmlformats.org/officeDocument/2006/relationships/image" Target="../media/image31.tiff"/><Relationship Id="rId7" Type="http://schemas.openxmlformats.org/officeDocument/2006/relationships/image" Target="../media/image35.tiff"/><Relationship Id="rId2" Type="http://schemas.openxmlformats.org/officeDocument/2006/relationships/image" Target="../media/image3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4.tiff"/><Relationship Id="rId5" Type="http://schemas.openxmlformats.org/officeDocument/2006/relationships/image" Target="../media/image33.tiff"/><Relationship Id="rId4" Type="http://schemas.openxmlformats.org/officeDocument/2006/relationships/image" Target="../media/image32.tiff"/><Relationship Id="rId9" Type="http://schemas.openxmlformats.org/officeDocument/2006/relationships/image" Target="../media/image37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jpeg"/><Relationship Id="rId2" Type="http://schemas.openxmlformats.org/officeDocument/2006/relationships/image" Target="../media/image38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333360" y="588888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2A</a:t>
            </a:r>
            <a:endParaRPr lang="zh-CN" altLang="en-US" dirty="0"/>
          </a:p>
        </p:txBody>
      </p:sp>
      <p:sp>
        <p:nvSpPr>
          <p:cNvPr id="5" name="文本框 4"/>
          <p:cNvSpPr txBox="1"/>
          <p:nvPr/>
        </p:nvSpPr>
        <p:spPr>
          <a:xfrm>
            <a:off x="8074205" y="399276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2C</a:t>
            </a:r>
            <a:endParaRPr lang="zh-CN" altLang="en-US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CE9F2257-654A-9DEF-F5B5-72E2B002A57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6040" y="1207008"/>
            <a:ext cx="2492377" cy="1999698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8516C9C4-5CC2-E9C5-B395-BE0A4FAB9E4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6041" y="3508005"/>
            <a:ext cx="2492377" cy="1999698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B7E6B520-9550-04A0-6424-6406A0AA798B}"/>
              </a:ext>
            </a:extLst>
          </p:cNvPr>
          <p:cNvSpPr txBox="1"/>
          <p:nvPr/>
        </p:nvSpPr>
        <p:spPr>
          <a:xfrm rot="-5400000">
            <a:off x="883486" y="1801061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UB1b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30FE183-A2E5-1AC4-72FA-0BAD70331461}"/>
              </a:ext>
            </a:extLst>
          </p:cNvPr>
          <p:cNvSpPr txBox="1"/>
          <p:nvPr/>
        </p:nvSpPr>
        <p:spPr>
          <a:xfrm rot="-5400000">
            <a:off x="883486" y="4096512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ubulin</a:t>
            </a:r>
            <a:endParaRPr lang="zh-CN" altLang="en-US" dirty="0"/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169EFFFA-C1F4-423D-CCEC-AB21EE38F2A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159710"/>
            <a:ext cx="2243478" cy="180000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B78872C3-C0E1-FBC9-EAF1-539CE92AA12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87127" y="1159710"/>
            <a:ext cx="2243478" cy="1800000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96690207-8521-BC93-19C7-164C7061D808}"/>
              </a:ext>
            </a:extLst>
          </p:cNvPr>
          <p:cNvSpPr txBox="1"/>
          <p:nvPr/>
        </p:nvSpPr>
        <p:spPr>
          <a:xfrm>
            <a:off x="7643280" y="768608"/>
            <a:ext cx="2782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549 BUB1B knockdown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CFF7A004-ED54-6668-28BB-EF68997AC9C3}"/>
              </a:ext>
            </a:extLst>
          </p:cNvPr>
          <p:cNvSpPr txBox="1"/>
          <p:nvPr/>
        </p:nvSpPr>
        <p:spPr>
          <a:xfrm rot="-5400000">
            <a:off x="8074205" y="1543557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UB1b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0ED35AE-C558-0DA6-2E8C-5A2FA34499A1}"/>
              </a:ext>
            </a:extLst>
          </p:cNvPr>
          <p:cNvSpPr txBox="1"/>
          <p:nvPr/>
        </p:nvSpPr>
        <p:spPr>
          <a:xfrm rot="-5400000">
            <a:off x="5283078" y="1603667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ubulin</a:t>
            </a:r>
            <a:endParaRPr lang="zh-CN" altLang="en-US" dirty="0"/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564AC417-D050-45DA-AF93-474592071DD8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632" y="3663271"/>
            <a:ext cx="2243478" cy="1800000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7EF28CA0-F817-EA2A-CD0C-F9D30D5ABD53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86759" y="3663271"/>
            <a:ext cx="2243478" cy="1800000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27C1D616-5D31-2BB4-53BE-A1EB5E6791F3}"/>
              </a:ext>
            </a:extLst>
          </p:cNvPr>
          <p:cNvSpPr txBox="1"/>
          <p:nvPr/>
        </p:nvSpPr>
        <p:spPr>
          <a:xfrm rot="-5400000">
            <a:off x="8074205" y="4036402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UB1b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DFE84860-A960-D4C2-937A-7BB71D8893B4}"/>
              </a:ext>
            </a:extLst>
          </p:cNvPr>
          <p:cNvSpPr txBox="1"/>
          <p:nvPr/>
        </p:nvSpPr>
        <p:spPr>
          <a:xfrm rot="-5400000">
            <a:off x="5283078" y="4096512"/>
            <a:ext cx="1255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ubulin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FD060F02-1865-7150-23EC-1606B6D78ACC}"/>
              </a:ext>
            </a:extLst>
          </p:cNvPr>
          <p:cNvSpPr txBox="1"/>
          <p:nvPr/>
        </p:nvSpPr>
        <p:spPr>
          <a:xfrm>
            <a:off x="7674748" y="3290772"/>
            <a:ext cx="3190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460 BUB1B overexpressio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19012125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B087061-C4B8-FDFD-112A-C7622AD0162E}"/>
              </a:ext>
            </a:extLst>
          </p:cNvPr>
          <p:cNvSpPr txBox="1"/>
          <p:nvPr/>
        </p:nvSpPr>
        <p:spPr>
          <a:xfrm>
            <a:off x="4656147" y="383936"/>
            <a:ext cx="3126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ure 3G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42E993AC-70D0-6663-9A1D-3AEC4669763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6492" y="1544918"/>
            <a:ext cx="2243478" cy="1800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BF3A3171-3926-EAA1-12D3-520B65AAA51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6492" y="3733695"/>
            <a:ext cx="2243478" cy="180000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93D42B56-4CC6-70E0-C8D7-1B6A0A35C097}"/>
              </a:ext>
            </a:extLst>
          </p:cNvPr>
          <p:cNvSpPr txBox="1"/>
          <p:nvPr/>
        </p:nvSpPr>
        <p:spPr>
          <a:xfrm>
            <a:off x="3416492" y="1125702"/>
            <a:ext cx="24248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549-shBUB1b NRF2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67AFDE1-B90B-9F90-AF77-AF23F10206E4}"/>
              </a:ext>
            </a:extLst>
          </p:cNvPr>
          <p:cNvSpPr txBox="1"/>
          <p:nvPr/>
        </p:nvSpPr>
        <p:spPr>
          <a:xfrm>
            <a:off x="3311389" y="3392174"/>
            <a:ext cx="27162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549-shBUB1b Tubulin</a:t>
            </a:r>
            <a:endParaRPr lang="zh-CN" altLang="en-US" dirty="0"/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61BBA700-8E4E-0EE2-B515-918FEB11E29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4802" y="1544918"/>
            <a:ext cx="2243478" cy="18000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3C570375-ADA2-4F7B-17C1-C53B90239DB8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4802" y="3733695"/>
            <a:ext cx="2243478" cy="180000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2454497D-5D4B-2C76-D37F-0CB1CB0D3F96}"/>
              </a:ext>
            </a:extLst>
          </p:cNvPr>
          <p:cNvSpPr txBox="1"/>
          <p:nvPr/>
        </p:nvSpPr>
        <p:spPr>
          <a:xfrm>
            <a:off x="6184307" y="1136215"/>
            <a:ext cx="24248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460 BUB1b NRF2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88AC73B-ACC7-6E2F-BE41-425D6F918346}"/>
              </a:ext>
            </a:extLst>
          </p:cNvPr>
          <p:cNvSpPr txBox="1"/>
          <p:nvPr/>
        </p:nvSpPr>
        <p:spPr>
          <a:xfrm>
            <a:off x="6184307" y="3394006"/>
            <a:ext cx="24248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460 BUB1b Tubul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10682496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112" y="1502168"/>
            <a:ext cx="1835514" cy="147268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6196" y="1502168"/>
            <a:ext cx="1835514" cy="147268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8552" y="1502168"/>
            <a:ext cx="1835514" cy="147268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31149" y="1502168"/>
            <a:ext cx="1835514" cy="147268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36527" y="1502168"/>
            <a:ext cx="1835514" cy="147268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283228" y="1116461"/>
            <a:ext cx="2265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4I_A549_NRF2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2643333" y="1116461"/>
            <a:ext cx="2301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4I_A549_GPX4</a:t>
            </a:r>
            <a:endParaRPr lang="zh-CN" altLang="en-US" dirty="0"/>
          </a:p>
        </p:txBody>
      </p:sp>
      <p:sp>
        <p:nvSpPr>
          <p:cNvPr id="12" name="文本框 11"/>
          <p:cNvSpPr txBox="1"/>
          <p:nvPr/>
        </p:nvSpPr>
        <p:spPr>
          <a:xfrm>
            <a:off x="5005434" y="1116461"/>
            <a:ext cx="2181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4I_A549_xCT</a:t>
            </a:r>
            <a:endParaRPr lang="zh-CN" altLang="en-US" dirty="0"/>
          </a:p>
        </p:txBody>
      </p:sp>
      <p:sp>
        <p:nvSpPr>
          <p:cNvPr id="13" name="文本框 12"/>
          <p:cNvSpPr txBox="1"/>
          <p:nvPr/>
        </p:nvSpPr>
        <p:spPr>
          <a:xfrm>
            <a:off x="7183046" y="1116461"/>
            <a:ext cx="2331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4I_A549_HO-1</a:t>
            </a:r>
            <a:endParaRPr lang="zh-CN" altLang="en-US" dirty="0"/>
          </a:p>
        </p:txBody>
      </p:sp>
      <p:sp>
        <p:nvSpPr>
          <p:cNvPr id="14" name="文本框 13"/>
          <p:cNvSpPr txBox="1"/>
          <p:nvPr/>
        </p:nvSpPr>
        <p:spPr>
          <a:xfrm>
            <a:off x="9448800" y="1116461"/>
            <a:ext cx="2410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4I_A549_Tublin</a:t>
            </a:r>
            <a:endParaRPr lang="zh-CN" altLang="en-US" dirty="0"/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3974" y="4263585"/>
            <a:ext cx="1839652" cy="1476000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9989" y="4263585"/>
            <a:ext cx="1839652" cy="1476000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4414" y="4263585"/>
            <a:ext cx="1839652" cy="147600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22873" y="4263585"/>
            <a:ext cx="1839652" cy="147600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32389" y="4263585"/>
            <a:ext cx="1839652" cy="1476000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213124" y="3894253"/>
            <a:ext cx="22992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4I_H460_NRF2</a:t>
            </a:r>
            <a:endParaRPr lang="zh-CN" altLang="en-US" dirty="0"/>
          </a:p>
        </p:txBody>
      </p:sp>
      <p:sp>
        <p:nvSpPr>
          <p:cNvPr id="21" name="文本框 20"/>
          <p:cNvSpPr txBox="1"/>
          <p:nvPr/>
        </p:nvSpPr>
        <p:spPr>
          <a:xfrm>
            <a:off x="2573229" y="3894253"/>
            <a:ext cx="2301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4I_H460_GPX4</a:t>
            </a:r>
            <a:endParaRPr lang="zh-CN" altLang="en-US" dirty="0"/>
          </a:p>
        </p:txBody>
      </p:sp>
      <p:sp>
        <p:nvSpPr>
          <p:cNvPr id="22" name="文本框 21"/>
          <p:cNvSpPr txBox="1"/>
          <p:nvPr/>
        </p:nvSpPr>
        <p:spPr>
          <a:xfrm>
            <a:off x="4935330" y="3894253"/>
            <a:ext cx="2181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4I_H460_xCT</a:t>
            </a:r>
            <a:endParaRPr lang="zh-CN" altLang="en-US" dirty="0"/>
          </a:p>
        </p:txBody>
      </p:sp>
      <p:sp>
        <p:nvSpPr>
          <p:cNvPr id="23" name="文本框 22"/>
          <p:cNvSpPr txBox="1"/>
          <p:nvPr/>
        </p:nvSpPr>
        <p:spPr>
          <a:xfrm>
            <a:off x="7112942" y="3894253"/>
            <a:ext cx="2331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4I_H460_HO-1</a:t>
            </a:r>
            <a:endParaRPr lang="zh-CN" altLang="en-US" dirty="0"/>
          </a:p>
        </p:txBody>
      </p:sp>
      <p:sp>
        <p:nvSpPr>
          <p:cNvPr id="24" name="文本框 23"/>
          <p:cNvSpPr txBox="1"/>
          <p:nvPr/>
        </p:nvSpPr>
        <p:spPr>
          <a:xfrm>
            <a:off x="9378696" y="3894253"/>
            <a:ext cx="2410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4I_H460_Tubl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12353844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048" y="1097279"/>
            <a:ext cx="2639568" cy="2117793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083" y="1097279"/>
            <a:ext cx="2639568" cy="2117793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8499" y="1097279"/>
            <a:ext cx="2639568" cy="2117793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17533" y="1097279"/>
            <a:ext cx="2639568" cy="2117793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048" y="3986783"/>
            <a:ext cx="2639568" cy="2117793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083" y="3986783"/>
            <a:ext cx="2639568" cy="2117793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8499" y="3986783"/>
            <a:ext cx="2639568" cy="2117793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17533" y="3986783"/>
            <a:ext cx="2639568" cy="2117793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194691" y="727947"/>
            <a:ext cx="3018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A_left_OTUD3_Input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6259449" y="727947"/>
            <a:ext cx="2677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A_left_OTUD3_Ip</a:t>
            </a:r>
            <a:endParaRPr lang="zh-CN" altLang="en-US" dirty="0"/>
          </a:p>
        </p:txBody>
      </p:sp>
      <p:sp>
        <p:nvSpPr>
          <p:cNvPr id="12" name="文本框 11"/>
          <p:cNvSpPr txBox="1"/>
          <p:nvPr/>
        </p:nvSpPr>
        <p:spPr>
          <a:xfrm>
            <a:off x="3200019" y="727947"/>
            <a:ext cx="2901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A_left_BUB1b_Input</a:t>
            </a:r>
            <a:endParaRPr lang="zh-CN" altLang="en-US" dirty="0"/>
          </a:p>
        </p:txBody>
      </p:sp>
      <p:sp>
        <p:nvSpPr>
          <p:cNvPr id="13" name="文本框 12"/>
          <p:cNvSpPr txBox="1"/>
          <p:nvPr/>
        </p:nvSpPr>
        <p:spPr>
          <a:xfrm>
            <a:off x="9177147" y="727947"/>
            <a:ext cx="2720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A_left_BUB1b_Ip</a:t>
            </a:r>
            <a:endParaRPr lang="zh-CN" altLang="en-US" dirty="0"/>
          </a:p>
        </p:txBody>
      </p:sp>
      <p:sp>
        <p:nvSpPr>
          <p:cNvPr id="14" name="文本框 13"/>
          <p:cNvSpPr txBox="1"/>
          <p:nvPr/>
        </p:nvSpPr>
        <p:spPr>
          <a:xfrm>
            <a:off x="136398" y="3578328"/>
            <a:ext cx="3134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A_right_OTUD3_Input</a:t>
            </a:r>
            <a:endParaRPr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>
            <a:off x="6145530" y="3578328"/>
            <a:ext cx="29055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A_right_OTUD3_Ip</a:t>
            </a:r>
            <a:endParaRPr lang="zh-CN" altLang="en-US" dirty="0"/>
          </a:p>
        </p:txBody>
      </p:sp>
      <p:sp>
        <p:nvSpPr>
          <p:cNvPr id="16" name="文本框 15"/>
          <p:cNvSpPr txBox="1"/>
          <p:nvPr/>
        </p:nvSpPr>
        <p:spPr>
          <a:xfrm>
            <a:off x="3129534" y="3578328"/>
            <a:ext cx="30426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A_right_BUB1b_Input</a:t>
            </a:r>
            <a:endParaRPr lang="zh-CN" altLang="en-US" dirty="0"/>
          </a:p>
        </p:txBody>
      </p:sp>
      <p:sp>
        <p:nvSpPr>
          <p:cNvPr id="17" name="文本框 16"/>
          <p:cNvSpPr txBox="1"/>
          <p:nvPr/>
        </p:nvSpPr>
        <p:spPr>
          <a:xfrm>
            <a:off x="9138666" y="3578328"/>
            <a:ext cx="27973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A_right_BUB1b_Ip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75270910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680" y="1670304"/>
            <a:ext cx="2932176" cy="235256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7248" y="1670304"/>
            <a:ext cx="2932176" cy="235256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7816" y="1670304"/>
            <a:ext cx="2932176" cy="235256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68384" y="1670304"/>
            <a:ext cx="2932176" cy="235256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554546" y="1227819"/>
            <a:ext cx="20364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B_OTUD3</a:t>
            </a:r>
            <a:endParaRPr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3626930" y="1227819"/>
            <a:ext cx="19328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B_BUB1b</a:t>
            </a:r>
            <a:endParaRPr lang="zh-CN" altLang="en-US" dirty="0"/>
          </a:p>
        </p:txBody>
      </p:sp>
      <p:sp>
        <p:nvSpPr>
          <p:cNvPr id="8" name="文本框 7"/>
          <p:cNvSpPr txBox="1"/>
          <p:nvPr/>
        </p:nvSpPr>
        <p:spPr>
          <a:xfrm>
            <a:off x="6741986" y="1227819"/>
            <a:ext cx="1743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B_NRF2</a:t>
            </a:r>
            <a:endParaRPr lang="zh-CN" altLang="en-US" dirty="0"/>
          </a:p>
        </p:txBody>
      </p:sp>
      <p:sp>
        <p:nvSpPr>
          <p:cNvPr id="9" name="文本框 8"/>
          <p:cNvSpPr txBox="1"/>
          <p:nvPr/>
        </p:nvSpPr>
        <p:spPr>
          <a:xfrm>
            <a:off x="9722930" y="1227819"/>
            <a:ext cx="18230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B_Tubl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5633934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2784" y="2107513"/>
            <a:ext cx="3590544" cy="2880788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9968" y="2107513"/>
            <a:ext cx="3590544" cy="2880788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2807018" y="1642347"/>
            <a:ext cx="20364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C_IB</a:t>
            </a:r>
            <a:r>
              <a:rPr lang="zh-CN" altLang="en-US" dirty="0"/>
              <a:t>：</a:t>
            </a:r>
            <a:r>
              <a:rPr lang="en-US" altLang="zh-CN" dirty="0"/>
              <a:t>HA</a:t>
            </a:r>
            <a:endParaRPr lang="zh-CN" altLang="en-US" dirty="0"/>
          </a:p>
        </p:txBody>
      </p:sp>
      <p:sp>
        <p:nvSpPr>
          <p:cNvPr id="5" name="文本框 4"/>
          <p:cNvSpPr txBox="1"/>
          <p:nvPr/>
        </p:nvSpPr>
        <p:spPr>
          <a:xfrm>
            <a:off x="6868573" y="1642347"/>
            <a:ext cx="23989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C_Input:NRF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290455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3528" y="2133600"/>
            <a:ext cx="2324961" cy="1865376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3904" y="2133600"/>
            <a:ext cx="2324961" cy="1865376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4280" y="2133600"/>
            <a:ext cx="2324961" cy="1865376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34656" y="2133600"/>
            <a:ext cx="2324961" cy="1865376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837872" y="1642347"/>
            <a:ext cx="2556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D_Input</a:t>
            </a:r>
            <a:r>
              <a:rPr lang="zh-CN" altLang="en-US" dirty="0"/>
              <a:t>：</a:t>
            </a:r>
            <a:r>
              <a:rPr lang="en-US" altLang="zh-CN" dirty="0"/>
              <a:t>NRF2</a:t>
            </a:r>
            <a:endParaRPr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3334848" y="1642347"/>
            <a:ext cx="2883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D_Input</a:t>
            </a:r>
            <a:r>
              <a:rPr lang="zh-CN" altLang="en-US" dirty="0"/>
              <a:t>：</a:t>
            </a:r>
            <a:r>
              <a:rPr lang="en-US" altLang="zh-CN" dirty="0"/>
              <a:t>OTUD3</a:t>
            </a:r>
            <a:endParaRPr lang="zh-CN" altLang="en-US" dirty="0"/>
          </a:p>
        </p:txBody>
      </p:sp>
      <p:sp>
        <p:nvSpPr>
          <p:cNvPr id="8" name="文本框 7"/>
          <p:cNvSpPr txBox="1"/>
          <p:nvPr/>
        </p:nvSpPr>
        <p:spPr>
          <a:xfrm>
            <a:off x="6370044" y="1642347"/>
            <a:ext cx="21334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D_I</a:t>
            </a:r>
            <a:r>
              <a:rPr lang="zh-CN" altLang="en-US" dirty="0"/>
              <a:t>：</a:t>
            </a:r>
            <a:r>
              <a:rPr lang="en-US" altLang="zh-CN" dirty="0"/>
              <a:t>NRF2</a:t>
            </a:r>
            <a:endParaRPr lang="zh-CN" altLang="en-US" dirty="0"/>
          </a:p>
        </p:txBody>
      </p:sp>
      <p:sp>
        <p:nvSpPr>
          <p:cNvPr id="9" name="文本框 8"/>
          <p:cNvSpPr txBox="1"/>
          <p:nvPr/>
        </p:nvSpPr>
        <p:spPr>
          <a:xfrm>
            <a:off x="8856021" y="1642347"/>
            <a:ext cx="2482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D_Ip</a:t>
            </a:r>
            <a:r>
              <a:rPr lang="zh-CN" altLang="en-US" dirty="0"/>
              <a:t>：</a:t>
            </a:r>
            <a:r>
              <a:rPr lang="en-US" altLang="zh-CN" dirty="0"/>
              <a:t>OTUD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2807789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BC4F1CA-712D-ED3B-0C68-B348BB65BE2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4782" y="1852344"/>
            <a:ext cx="2243478" cy="18000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FF8A61C-5971-B3A2-BB8B-A2E47479E0D7}"/>
              </a:ext>
            </a:extLst>
          </p:cNvPr>
          <p:cNvSpPr txBox="1"/>
          <p:nvPr/>
        </p:nvSpPr>
        <p:spPr>
          <a:xfrm>
            <a:off x="1631815" y="1483012"/>
            <a:ext cx="20364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H_GPX4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437C6D6D-187D-9348-027E-74BA82D1E27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5886" y="1852344"/>
            <a:ext cx="2243478" cy="180000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0911BC04-BCBF-D934-AACA-28DB058AECED}"/>
              </a:ext>
            </a:extLst>
          </p:cNvPr>
          <p:cNvSpPr txBox="1"/>
          <p:nvPr/>
        </p:nvSpPr>
        <p:spPr>
          <a:xfrm>
            <a:off x="4022919" y="1483012"/>
            <a:ext cx="20364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H_HO-1</a:t>
            </a:r>
            <a:endParaRPr lang="zh-CN" altLang="en-US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C39FBDBA-C520-0C19-B5A6-64044210CFE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6990" y="1852344"/>
            <a:ext cx="2243478" cy="180000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1151BC7F-C2FB-FC69-1ED5-A67E1D81D51E}"/>
              </a:ext>
            </a:extLst>
          </p:cNvPr>
          <p:cNvSpPr txBox="1"/>
          <p:nvPr/>
        </p:nvSpPr>
        <p:spPr>
          <a:xfrm>
            <a:off x="6366726" y="1483012"/>
            <a:ext cx="20364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H_xCT</a:t>
            </a:r>
            <a:endParaRPr lang="zh-CN" altLang="en-US" dirty="0"/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147ACC31-EF13-CA4A-CF6B-F91CAF7167B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98094" y="1852344"/>
            <a:ext cx="2243478" cy="180000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3A45B40D-6E98-ECF5-8C2A-C35094F4CE17}"/>
              </a:ext>
            </a:extLst>
          </p:cNvPr>
          <p:cNvSpPr txBox="1"/>
          <p:nvPr/>
        </p:nvSpPr>
        <p:spPr>
          <a:xfrm>
            <a:off x="8805127" y="1474290"/>
            <a:ext cx="20364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5H_Tubl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72334594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8391FEB-16A5-75D1-66E2-DE996A2F2D0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5541" y="1899640"/>
            <a:ext cx="2243478" cy="18000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7A46EAB0-EEB5-5CFE-98E1-E6297F5F767D}"/>
              </a:ext>
            </a:extLst>
          </p:cNvPr>
          <p:cNvSpPr txBox="1"/>
          <p:nvPr/>
        </p:nvSpPr>
        <p:spPr>
          <a:xfrm>
            <a:off x="788340" y="909453"/>
            <a:ext cx="3126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ure 5A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C661756-E2BF-065C-22EB-B66102F3902A}"/>
              </a:ext>
            </a:extLst>
          </p:cNvPr>
          <p:cNvSpPr txBox="1"/>
          <p:nvPr/>
        </p:nvSpPr>
        <p:spPr>
          <a:xfrm>
            <a:off x="1647844" y="1530308"/>
            <a:ext cx="14077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UB1b</a:t>
            </a:r>
            <a:endParaRPr lang="zh-CN" altLang="en-US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A9C6D905-F062-0D11-00BE-2C7908454FB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5044" y="1899640"/>
            <a:ext cx="2243478" cy="180000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23BD2992-BD6F-F845-2CB2-F3FAD080ABD6}"/>
              </a:ext>
            </a:extLst>
          </p:cNvPr>
          <p:cNvSpPr txBox="1"/>
          <p:nvPr/>
        </p:nvSpPr>
        <p:spPr>
          <a:xfrm>
            <a:off x="6282905" y="1553435"/>
            <a:ext cx="1578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Input OTUD3</a:t>
            </a:r>
            <a:endParaRPr lang="zh-CN" altLang="en-US" dirty="0"/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EB51B1B2-F4A6-B0A4-8092-678E6CFB557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46148" y="1899640"/>
            <a:ext cx="2243478" cy="180000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BFE3F1E2-2620-6CC6-21B1-CE595BF5822F}"/>
              </a:ext>
            </a:extLst>
          </p:cNvPr>
          <p:cNvSpPr txBox="1"/>
          <p:nvPr/>
        </p:nvSpPr>
        <p:spPr>
          <a:xfrm>
            <a:off x="8526383" y="1552382"/>
            <a:ext cx="1578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Input NRF2</a:t>
            </a:r>
            <a:endParaRPr lang="zh-CN" altLang="en-US" dirty="0"/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9E459B67-E2B5-B787-F59A-D0DFD3C57050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5044" y="4046898"/>
            <a:ext cx="2243478" cy="1800000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967E3063-24BF-DDD2-C685-EBAA83EE8927}"/>
              </a:ext>
            </a:extLst>
          </p:cNvPr>
          <p:cNvSpPr txBox="1"/>
          <p:nvPr/>
        </p:nvSpPr>
        <p:spPr>
          <a:xfrm>
            <a:off x="6282905" y="3688603"/>
            <a:ext cx="1578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IP OTUD3</a:t>
            </a:r>
            <a:endParaRPr lang="zh-CN" altLang="en-US" dirty="0"/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EA5D5AEC-7B45-DC1C-4304-02676A43519E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46148" y="4057935"/>
            <a:ext cx="2243478" cy="1800000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0DE15F5C-EE38-9257-7379-28BA181D901D}"/>
              </a:ext>
            </a:extLst>
          </p:cNvPr>
          <p:cNvSpPr txBox="1"/>
          <p:nvPr/>
        </p:nvSpPr>
        <p:spPr>
          <a:xfrm>
            <a:off x="8631968" y="3699640"/>
            <a:ext cx="1578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IP NRF2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71418031-CB88-B7DB-5002-CAD14DC9F230}"/>
              </a:ext>
            </a:extLst>
          </p:cNvPr>
          <p:cNvSpPr txBox="1"/>
          <p:nvPr/>
        </p:nvSpPr>
        <p:spPr>
          <a:xfrm>
            <a:off x="6582766" y="951495"/>
            <a:ext cx="3126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ure 5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978738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2B12691-E4E2-6A24-3745-7CB2E435ABE3}"/>
              </a:ext>
            </a:extLst>
          </p:cNvPr>
          <p:cNvSpPr txBox="1"/>
          <p:nvPr/>
        </p:nvSpPr>
        <p:spPr>
          <a:xfrm>
            <a:off x="4251498" y="478529"/>
            <a:ext cx="3126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ure 2A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591846E0-177B-C889-5FC6-3462EBF8DB1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8370" y="1715709"/>
            <a:ext cx="2243478" cy="1800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3982454A-8E5A-9130-C300-68DFDDBCA7B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1402" y="1715709"/>
            <a:ext cx="2243478" cy="180000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7D887386-59F6-1A87-FF7A-4FD4B8FABBA3}"/>
              </a:ext>
            </a:extLst>
          </p:cNvPr>
          <p:cNvSpPr txBox="1"/>
          <p:nvPr/>
        </p:nvSpPr>
        <p:spPr>
          <a:xfrm>
            <a:off x="4049680" y="1362263"/>
            <a:ext cx="1554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BE BUB1b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3F4C6B3-C891-48CA-FAE7-338B40749981}"/>
              </a:ext>
            </a:extLst>
          </p:cNvPr>
          <p:cNvSpPr txBox="1"/>
          <p:nvPr/>
        </p:nvSpPr>
        <p:spPr>
          <a:xfrm>
            <a:off x="6771175" y="1346377"/>
            <a:ext cx="1554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BE Tubul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325688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3536" y="967777"/>
            <a:ext cx="2737104" cy="2196048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2084832" y="556382"/>
            <a:ext cx="3395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 A549_left BUB1B input</a:t>
            </a:r>
            <a:endParaRPr lang="zh-CN" altLang="en-US" dirty="0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5792" y="938431"/>
            <a:ext cx="2773680" cy="2225394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5791200" y="556382"/>
            <a:ext cx="31028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 A549_left BUB1B </a:t>
            </a:r>
            <a:r>
              <a:rPr lang="en-US" altLang="zh-CN" dirty="0" err="1"/>
              <a:t>ip</a:t>
            </a:r>
            <a:endParaRPr lang="zh-CN" altLang="en-US" dirty="0"/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3536" y="3767328"/>
            <a:ext cx="2798064" cy="2244958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2084832" y="3397996"/>
            <a:ext cx="3395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 A549_left NRF2 input</a:t>
            </a:r>
            <a:endParaRPr lang="zh-CN" altLang="en-US" dirty="0"/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31409" y="3767328"/>
            <a:ext cx="2798063" cy="2244958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5748528" y="3397996"/>
            <a:ext cx="3395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 A549_left NRF2 </a:t>
            </a:r>
            <a:r>
              <a:rPr lang="en-US" altLang="zh-CN" dirty="0" err="1"/>
              <a:t>ip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142A4157-C66B-930A-7429-7EAF806832D3}"/>
              </a:ext>
            </a:extLst>
          </p:cNvPr>
          <p:cNvSpPr txBox="1"/>
          <p:nvPr/>
        </p:nvSpPr>
        <p:spPr>
          <a:xfrm>
            <a:off x="4953032" y="69965"/>
            <a:ext cx="1305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 Figure 3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336769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6356" y="707136"/>
            <a:ext cx="2432304" cy="19515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604772" y="337804"/>
            <a:ext cx="3395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 A549_right BUB1B input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5203" y="707137"/>
            <a:ext cx="2505456" cy="2010192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5812823" y="337804"/>
            <a:ext cx="3270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 A549_right NRF2 input</a:t>
            </a:r>
            <a:endParaRPr lang="zh-CN" altLang="en-US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1868" y="3608832"/>
            <a:ext cx="2621280" cy="210312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604772" y="3239500"/>
            <a:ext cx="3395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 A549_right BUB1B </a:t>
            </a:r>
            <a:r>
              <a:rPr lang="en-US" altLang="zh-CN" dirty="0" err="1"/>
              <a:t>ip</a:t>
            </a:r>
            <a:endParaRPr lang="zh-CN" altLang="en-US" dirty="0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2709" y="3608832"/>
            <a:ext cx="2750445" cy="2206752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5972699" y="3133039"/>
            <a:ext cx="2950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 A549_right NRF2 </a:t>
            </a:r>
            <a:r>
              <a:rPr lang="en-US" altLang="zh-CN" dirty="0" err="1"/>
              <a:t>ip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AE5E1C6F-34C9-C701-1817-4F0D81E6A462}"/>
              </a:ext>
            </a:extLst>
          </p:cNvPr>
          <p:cNvSpPr txBox="1"/>
          <p:nvPr/>
        </p:nvSpPr>
        <p:spPr>
          <a:xfrm>
            <a:off x="4790121" y="0"/>
            <a:ext cx="1305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 Figure 3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1839136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7273" y="1289829"/>
            <a:ext cx="2798064" cy="2244958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853289" y="725425"/>
            <a:ext cx="4066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 H460-BUB1b_left BUB1B input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46497" y="1379993"/>
            <a:ext cx="2822448" cy="2264522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6324705" y="725425"/>
            <a:ext cx="4066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 H460-BUB1b_left NRF2 input</a:t>
            </a:r>
            <a:endParaRPr lang="zh-CN" altLang="en-US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7273" y="4093989"/>
            <a:ext cx="2798064" cy="2244958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996545" y="3644515"/>
            <a:ext cx="3779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 H460-BUB1b_left BUB1B </a:t>
            </a:r>
            <a:r>
              <a:rPr lang="en-US" altLang="zh-CN" dirty="0" err="1"/>
              <a:t>ip</a:t>
            </a:r>
            <a:endParaRPr lang="zh-CN" altLang="en-US" dirty="0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1324" y="4093989"/>
            <a:ext cx="2932794" cy="2353056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6559556" y="3724657"/>
            <a:ext cx="35963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 H460-BUB1b_left NRF2 </a:t>
            </a:r>
            <a:r>
              <a:rPr lang="en-US" altLang="zh-CN" dirty="0" err="1"/>
              <a:t>ip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41091912-2E75-C2BC-BC8D-2160F56A6C21}"/>
              </a:ext>
            </a:extLst>
          </p:cNvPr>
          <p:cNvSpPr txBox="1"/>
          <p:nvPr/>
        </p:nvSpPr>
        <p:spPr>
          <a:xfrm>
            <a:off x="5515335" y="70857"/>
            <a:ext cx="1305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 Figure 3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987447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8969" y="1147730"/>
            <a:ext cx="2940303" cy="235908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602792" y="668670"/>
            <a:ext cx="42326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 H460-BUB1b_right BUB1B input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3817" y="1166231"/>
            <a:ext cx="3054096" cy="2450379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5987849" y="668670"/>
            <a:ext cx="4066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 H460-BUB1b_right NRF2 input</a:t>
            </a:r>
            <a:endParaRPr lang="zh-CN" altLang="en-US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9128" y="4305458"/>
            <a:ext cx="2919984" cy="2342778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752143" y="3930243"/>
            <a:ext cx="39339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 H460-BUB1b_right BUB1B </a:t>
            </a:r>
            <a:r>
              <a:rPr lang="en-US" altLang="zh-CN" dirty="0" err="1"/>
              <a:t>ip</a:t>
            </a:r>
            <a:endParaRPr lang="zh-CN" altLang="en-US" dirty="0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1283" y="4209836"/>
            <a:ext cx="3039165" cy="243840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6128057" y="3840504"/>
            <a:ext cx="3785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 H460-BUB1b_right NRF2 </a:t>
            </a:r>
            <a:r>
              <a:rPr lang="en-US" altLang="zh-CN" dirty="0" err="1"/>
              <a:t>ip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21853BC-5A3B-DDA8-E4E3-E9A6A8E8DDE2}"/>
              </a:ext>
            </a:extLst>
          </p:cNvPr>
          <p:cNvSpPr txBox="1"/>
          <p:nvPr/>
        </p:nvSpPr>
        <p:spPr>
          <a:xfrm>
            <a:off x="5207595" y="87622"/>
            <a:ext cx="1305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 Figure 3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565553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1640" y="803183"/>
            <a:ext cx="2212848" cy="177542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584960" y="341376"/>
            <a:ext cx="2426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C_A549_NRF2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4984" y="803183"/>
            <a:ext cx="2249424" cy="180477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4596384" y="341376"/>
            <a:ext cx="27066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C_A549_p-NRF2</a:t>
            </a:r>
            <a:endParaRPr lang="zh-CN" altLang="en-US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92440" y="803183"/>
            <a:ext cx="2334768" cy="1873244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7994904" y="341376"/>
            <a:ext cx="25298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C_A549_Tublin</a:t>
            </a:r>
            <a:endParaRPr lang="zh-CN" altLang="en-US" dirty="0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4960" y="3779023"/>
            <a:ext cx="2426208" cy="1946609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4984" y="3806880"/>
            <a:ext cx="2391488" cy="1918752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92440" y="3774132"/>
            <a:ext cx="2432304" cy="1951500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1584960" y="3311353"/>
            <a:ext cx="2426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C_H460_NRF2</a:t>
            </a:r>
            <a:endParaRPr lang="zh-CN" altLang="en-US" dirty="0"/>
          </a:p>
        </p:txBody>
      </p:sp>
      <p:sp>
        <p:nvSpPr>
          <p:cNvPr id="12" name="文本框 11"/>
          <p:cNvSpPr txBox="1"/>
          <p:nvPr/>
        </p:nvSpPr>
        <p:spPr>
          <a:xfrm>
            <a:off x="4596384" y="3311353"/>
            <a:ext cx="27066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C_H460_p-NRF2</a:t>
            </a:r>
            <a:endParaRPr lang="zh-CN" altLang="en-US" dirty="0"/>
          </a:p>
        </p:txBody>
      </p:sp>
      <p:sp>
        <p:nvSpPr>
          <p:cNvPr id="14" name="文本框 13"/>
          <p:cNvSpPr txBox="1"/>
          <p:nvPr/>
        </p:nvSpPr>
        <p:spPr>
          <a:xfrm>
            <a:off x="7967472" y="3311353"/>
            <a:ext cx="25298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C_H460_Tubl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20765735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679" y="755904"/>
            <a:ext cx="2552899" cy="2048256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487679" y="268224"/>
            <a:ext cx="2426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E_A549_GPX4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0128" y="755904"/>
            <a:ext cx="2542032" cy="2039538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364991" y="308274"/>
            <a:ext cx="2401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E_A549_HO-1</a:t>
            </a:r>
            <a:endParaRPr lang="zh-CN" altLang="en-US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7440" y="766218"/>
            <a:ext cx="2505456" cy="2010191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6077711" y="308274"/>
            <a:ext cx="28468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E_A549_SLC7A11</a:t>
            </a:r>
            <a:endParaRPr lang="zh-CN" altLang="en-US" dirty="0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28176" y="725495"/>
            <a:ext cx="2590800" cy="2078665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9079991" y="308274"/>
            <a:ext cx="24871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E_A549_Tublin</a:t>
            </a:r>
            <a:endParaRPr lang="zh-CN" altLang="en-US" dirty="0"/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660" y="3852671"/>
            <a:ext cx="2510227" cy="2014019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403660" y="3371088"/>
            <a:ext cx="2426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E_H460_GPX4</a:t>
            </a:r>
            <a:endParaRPr lang="zh-CN" altLang="en-US" dirty="0"/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1464" y="3861390"/>
            <a:ext cx="2499360" cy="200530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3310128" y="3371088"/>
            <a:ext cx="2401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E_H460_HO-1</a:t>
            </a:r>
            <a:endParaRPr lang="zh-CN" altLang="en-US" dirty="0"/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1884" y="3817264"/>
            <a:ext cx="2598486" cy="2084832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6016751" y="3371088"/>
            <a:ext cx="28468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E_H460_SLC7A11</a:t>
            </a:r>
            <a:endParaRPr lang="zh-CN" altLang="en-US" dirty="0"/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71430" y="3817264"/>
            <a:ext cx="2655163" cy="2130306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9255426" y="3360682"/>
            <a:ext cx="24871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3E_H460_Tubl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8354472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AE0CB5A4-46CC-BF75-0A66-97FED7A284D2}"/>
              </a:ext>
            </a:extLst>
          </p:cNvPr>
          <p:cNvSpPr txBox="1"/>
          <p:nvPr/>
        </p:nvSpPr>
        <p:spPr>
          <a:xfrm>
            <a:off x="4656147" y="383936"/>
            <a:ext cx="3126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ure 3B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9B2C86C4-EFFD-7D81-0B21-3A7E285A540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4408" y="1750282"/>
            <a:ext cx="2243478" cy="180000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285BE46F-5A23-868B-A683-9BADCBC51C28}"/>
              </a:ext>
            </a:extLst>
          </p:cNvPr>
          <p:cNvSpPr txBox="1"/>
          <p:nvPr/>
        </p:nvSpPr>
        <p:spPr>
          <a:xfrm>
            <a:off x="4083617" y="1067109"/>
            <a:ext cx="42718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549-shBUB1b NRF2 overexpression</a:t>
            </a:r>
            <a:endParaRPr lang="zh-CN" altLang="en-US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74BC560B-8C56-D79E-28C8-1628ADC5DF4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0669" y="1750282"/>
            <a:ext cx="2243478" cy="180000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F7768F0F-28F2-477F-F328-F80832CC51F7}"/>
              </a:ext>
            </a:extLst>
          </p:cNvPr>
          <p:cNvSpPr txBox="1"/>
          <p:nvPr/>
        </p:nvSpPr>
        <p:spPr>
          <a:xfrm>
            <a:off x="4324853" y="1436848"/>
            <a:ext cx="939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RF2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3514685-F8DE-39F2-DB4E-BB6281211BA1}"/>
              </a:ext>
            </a:extLst>
          </p:cNvPr>
          <p:cNvSpPr txBox="1"/>
          <p:nvPr/>
        </p:nvSpPr>
        <p:spPr>
          <a:xfrm>
            <a:off x="7185974" y="1436848"/>
            <a:ext cx="939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ubul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84615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</TotalTime>
  <Words>459</Words>
  <Application>Microsoft Office PowerPoint</Application>
  <PresentationFormat>宽屏</PresentationFormat>
  <Paragraphs>95</Paragraphs>
  <Slides>1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7</vt:i4>
      </vt:variant>
    </vt:vector>
  </HeadingPairs>
  <TitlesOfParts>
    <vt:vector size="21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n Tong</dc:creator>
  <cp:lastModifiedBy>健 高</cp:lastModifiedBy>
  <cp:revision>7</cp:revision>
  <dcterms:created xsi:type="dcterms:W3CDTF">2024-02-18T01:33:20Z</dcterms:created>
  <dcterms:modified xsi:type="dcterms:W3CDTF">2024-06-17T08:12:37Z</dcterms:modified>
</cp:coreProperties>
</file>